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5"/>
    <p:restoredTop sz="95588"/>
  </p:normalViewPr>
  <p:slideViewPr>
    <p:cSldViewPr snapToGrid="0" snapToObjects="1">
      <p:cViewPr varScale="1">
        <p:scale>
          <a:sx n="98" d="100"/>
          <a:sy n="98" d="100"/>
        </p:scale>
        <p:origin x="200" y="3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9862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271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87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0736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1893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7132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802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5754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937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0362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1309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5AC9D-7094-3F4C-8F25-46A57485A8A2}" type="datetimeFigureOut">
              <a:rPr kumimoji="1" lang="ja-JP" altLang="en-US" smtClean="0"/>
              <a:t>2021/8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F4EF05-F857-B74A-9618-1D016A922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9307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8986CB48-0F6B-BA41-BA14-4B5E0A82BD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919" y="489638"/>
            <a:ext cx="4320000" cy="288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EFB24DC-A9FF-A04F-AF0F-EB216AAF04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919" y="3638007"/>
            <a:ext cx="4320000" cy="28800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DD8BB285-3FC2-9C4A-A312-204DBE10402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05456" y="489638"/>
            <a:ext cx="4320000" cy="2880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BC54899-2CD5-4045-BCF6-796D5D9893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05456" y="3638007"/>
            <a:ext cx="4320000" cy="2880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D12BC75-3D5B-194B-AC65-EE60BF28D639}"/>
              </a:ext>
            </a:extLst>
          </p:cNvPr>
          <p:cNvSpPr txBox="1"/>
          <p:nvPr/>
        </p:nvSpPr>
        <p:spPr>
          <a:xfrm>
            <a:off x="0" y="0"/>
            <a:ext cx="13474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2A Fig.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581FC6B-3EC9-E74F-9525-D876E414BF35}"/>
              </a:ext>
            </a:extLst>
          </p:cNvPr>
          <p:cNvSpPr txBox="1"/>
          <p:nvPr/>
        </p:nvSpPr>
        <p:spPr>
          <a:xfrm>
            <a:off x="248466" y="555171"/>
            <a:ext cx="19928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1F upper left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uncropped) 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0A7314F-28FC-C94B-B612-073676959997}"/>
              </a:ext>
            </a:extLst>
          </p:cNvPr>
          <p:cNvSpPr txBox="1"/>
          <p:nvPr/>
        </p:nvSpPr>
        <p:spPr>
          <a:xfrm>
            <a:off x="4798770" y="555171"/>
            <a:ext cx="21339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1F upper right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uncropped) 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29E39D3-C8F8-8F4E-8155-4FA1591152E0}"/>
              </a:ext>
            </a:extLst>
          </p:cNvPr>
          <p:cNvSpPr txBox="1"/>
          <p:nvPr/>
        </p:nvSpPr>
        <p:spPr>
          <a:xfrm>
            <a:off x="204377" y="3638007"/>
            <a:ext cx="19543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1F lower left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uncropped) 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72DA9EC-EA8A-184B-ACDA-7C19D18E3461}"/>
              </a:ext>
            </a:extLst>
          </p:cNvPr>
          <p:cNvSpPr txBox="1"/>
          <p:nvPr/>
        </p:nvSpPr>
        <p:spPr>
          <a:xfrm>
            <a:off x="4754681" y="3638007"/>
            <a:ext cx="20954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1F lower right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uncropped) 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97342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AD744331-B4AC-D64B-8F32-47BDEE8777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9563" y="3758461"/>
            <a:ext cx="4320000" cy="2880000"/>
          </a:xfrm>
          <a:prstGeom prst="rect">
            <a:avLst/>
          </a:prstGeom>
        </p:spPr>
      </p:pic>
      <p:pic>
        <p:nvPicPr>
          <p:cNvPr id="3" name="図 2" descr="グラフィカル ユーザー インターフェイス&#10;&#10;中程度の精度で自動的に生成された説明">
            <a:extLst>
              <a:ext uri="{FF2B5EF4-FFF2-40B4-BE49-F238E27FC236}">
                <a16:creationId xmlns:a16="http://schemas.microsoft.com/office/drawing/2014/main" id="{68E03A3C-50E0-4641-90E4-8A895BD048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7434" y="3758461"/>
            <a:ext cx="4320000" cy="2879999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BCC8F95F-D217-8B44-AAAB-31EF38F480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7434" y="649864"/>
            <a:ext cx="4320000" cy="288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9C65CC5-AB01-EB4F-8A20-F030ACF950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89563" y="649864"/>
            <a:ext cx="4320000" cy="28800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61B664B-A623-5448-BBA6-39C95ED594DC}"/>
              </a:ext>
            </a:extLst>
          </p:cNvPr>
          <p:cNvSpPr txBox="1"/>
          <p:nvPr/>
        </p:nvSpPr>
        <p:spPr>
          <a:xfrm>
            <a:off x="0" y="0"/>
            <a:ext cx="13644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2B Fig.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35B3ABB-DD21-EF47-8D1A-B40E605408B2}"/>
              </a:ext>
            </a:extLst>
          </p:cNvPr>
          <p:cNvSpPr txBox="1"/>
          <p:nvPr/>
        </p:nvSpPr>
        <p:spPr>
          <a:xfrm>
            <a:off x="248466" y="555171"/>
            <a:ext cx="20185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1H upper left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uncropped) 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DEE1E0A-51C6-0C46-94C7-6B7BB0920AFB}"/>
              </a:ext>
            </a:extLst>
          </p:cNvPr>
          <p:cNvSpPr txBox="1"/>
          <p:nvPr/>
        </p:nvSpPr>
        <p:spPr>
          <a:xfrm>
            <a:off x="4798770" y="555171"/>
            <a:ext cx="21595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1H upper right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uncropped) 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F50E5A8-AA25-E84A-BBDB-2A01627059E5}"/>
              </a:ext>
            </a:extLst>
          </p:cNvPr>
          <p:cNvSpPr txBox="1"/>
          <p:nvPr/>
        </p:nvSpPr>
        <p:spPr>
          <a:xfrm>
            <a:off x="204377" y="3755574"/>
            <a:ext cx="19800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1H lower left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uncropped) 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E00A544-59C1-7E49-960A-48580B05BE1D}"/>
              </a:ext>
            </a:extLst>
          </p:cNvPr>
          <p:cNvSpPr txBox="1"/>
          <p:nvPr/>
        </p:nvSpPr>
        <p:spPr>
          <a:xfrm>
            <a:off x="4754681" y="3755574"/>
            <a:ext cx="21210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1H lower right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uncropped) 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05259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E8790130-B982-D241-BEF2-63B4019941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2096" y="558580"/>
            <a:ext cx="3937846" cy="5400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EBBD25D-FB94-624D-8CC4-B3FB9CF634DD}"/>
              </a:ext>
            </a:extLst>
          </p:cNvPr>
          <p:cNvSpPr txBox="1"/>
          <p:nvPr/>
        </p:nvSpPr>
        <p:spPr>
          <a:xfrm>
            <a:off x="0" y="0"/>
            <a:ext cx="13821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2C Fig.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BC82894-8D20-F84F-BD3A-75C2DC0E6F56}"/>
              </a:ext>
            </a:extLst>
          </p:cNvPr>
          <p:cNvSpPr txBox="1"/>
          <p:nvPr/>
        </p:nvSpPr>
        <p:spPr>
          <a:xfrm>
            <a:off x="3079284" y="2013422"/>
            <a:ext cx="14927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5I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uncropped) 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2934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79</Words>
  <Application>Microsoft Macintosh PowerPoint</Application>
  <PresentationFormat>画面に合わせる (4:3)</PresentationFormat>
  <Paragraphs>21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山 和久</dc:creator>
  <cp:lastModifiedBy>中山 和久</cp:lastModifiedBy>
  <cp:revision>4</cp:revision>
  <dcterms:created xsi:type="dcterms:W3CDTF">2021-08-21T07:43:36Z</dcterms:created>
  <dcterms:modified xsi:type="dcterms:W3CDTF">2021-08-21T08:03:57Z</dcterms:modified>
</cp:coreProperties>
</file>